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2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DCFFCD-C551-2969-F97A-2E3B029929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A1ACFB3-832C-0400-1A05-CF465D55EB5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FBEFFB4-E564-9276-1571-697863F8753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BEB90-376D-D972-5F7C-5DB043ABA29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18199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1448D5-9C38-AF0A-6A7C-9324CFC847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1B52001-8332-E048-FF71-9EBA4C0D15F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599F203-C1F0-8C79-B510-069DEC25428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0D9955-5F6E-B2C2-72BB-833D1CB437A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3407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3035" y="5429588"/>
            <a:ext cx="7113261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(2026) Diabetologia DOI 10.1007/s00125-026-06681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Pathophysiological pathways linking type 1 diabetes, ageing and adverse outcom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0671E3A-A67E-3424-6BFE-C0ACD5E7A2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467" y="980728"/>
            <a:ext cx="7637067" cy="4664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0DF987-A84D-EB12-1ABB-BEA9BB14DC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DEF194EE-F411-1ACD-7D1D-A292AA22AB8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F95074-776A-993D-B119-10F13FEBB9A4}"/>
              </a:ext>
            </a:extLst>
          </p:cNvPr>
          <p:cNvSpPr txBox="1"/>
          <p:nvPr/>
        </p:nvSpPr>
        <p:spPr>
          <a:xfrm>
            <a:off x="107504" y="5445224"/>
            <a:ext cx="702315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(2026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6-</a:t>
            </a:r>
            <a:r>
              <a:rPr lang="en-GB" dirty="0">
                <a:solidFill>
                  <a:prstClr val="black"/>
                </a:solidFill>
              </a:rPr>
              <a:t>06681-x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DB02C2-F9BA-9A06-7D04-069CE4AE0E58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Frailty management in type 1 diabetes: core domain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7899B5A-FD00-F35B-DDD1-3617EA9FEF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7946" y="1124744"/>
            <a:ext cx="6448108" cy="4413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7414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8DC940-75B5-5431-9BD4-459B4E4858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9218B3CC-81B8-763D-188C-1C58D4EFD04F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D634A70-DFF9-0091-D1DB-9FFCF82E7BBB}"/>
              </a:ext>
            </a:extLst>
          </p:cNvPr>
          <p:cNvSpPr txBox="1"/>
          <p:nvPr/>
        </p:nvSpPr>
        <p:spPr>
          <a:xfrm>
            <a:off x="107504" y="5445224"/>
            <a:ext cx="6926681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lvl="0"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(2026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6-</a:t>
            </a:r>
            <a:r>
              <a:rPr lang="en-GB" dirty="0">
                <a:solidFill>
                  <a:prstClr val="black"/>
                </a:solidFill>
              </a:rPr>
              <a:t>06681-x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C0AA06-AB6C-9846-361B-869541091DA4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Holistic approach to older people with type 1 diabetes according to frailty status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69D2C9-8F28-CF13-D2CA-DD240384AD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52907" y="856026"/>
            <a:ext cx="6038187" cy="4919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6491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3</cp:revision>
  <dcterms:created xsi:type="dcterms:W3CDTF">2016-06-15T12:53:43Z</dcterms:created>
  <dcterms:modified xsi:type="dcterms:W3CDTF">2026-02-06T12:21:05Z</dcterms:modified>
</cp:coreProperties>
</file>